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24600F-4937-4270-A752-7738F36877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ABA9E0-163B-442A-A57A-4A062A8769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6C84F2-F846-4FBC-A31C-530884B042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CEBB9-EF6D-4070-AA5F-141369E44B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A0A6C-5762-424F-AD84-22BC482DB5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0B1CF-5208-4A2A-8765-78AE3FCAAB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0C8B55-2AF7-4BAD-A012-FFE706C4B0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CF1815-EEDA-4510-839B-8D3E54F3E0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069C22-2DBA-4001-957C-77C1B5A606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A4506C-521D-4C73-BFDD-90203AFF37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315145-F5EF-4206-BA9E-FBA342EA97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B243D-9F61-4AE4-A557-2F3556F763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82F33C-109A-45DB-8F4E-F800F852670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62120" y="1722600"/>
          <a:ext cx="7772400" cy="3840120"/>
        </p:xfrm>
        <a:graphic>
          <a:graphicData uri="http://schemas.openxmlformats.org/drawingml/2006/table">
            <a:tbl>
              <a:tblPr/>
              <a:tblGrid>
                <a:gridCol w="2206440"/>
                <a:gridCol w="5565960"/>
              </a:tblGrid>
              <a:tr h="547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spase-3 and -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 kD N-terminal fragment and 89 kD C-terminal fragment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49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lpain-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~70-40 kD N-terminal fragmen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432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4900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thespsin-B and -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9, 74, 62 kD N-terminal fragments and 55, 44 kD C-terminal fragmen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432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479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thespsin-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4, 62 N-terminal fragments and 55, 44 kD C-terminal fragmen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432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49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anzyme-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5 kD N-terminal fragment and ~55 kD C-terminal fragmen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432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47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ranzyme-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4, 61 kD N-terminal fragments and  54, 42 kD C-terminal fragmen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432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49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MP-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&lt;48 kD and 66 kD fragmen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 w="4320">
                      <a:solidFill>
                        <a:srgbClr val="000000"/>
                      </a:solidFill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5"/>
          <p:cNvSpPr/>
          <p:nvPr/>
        </p:nvSpPr>
        <p:spPr>
          <a:xfrm>
            <a:off x="749520" y="1200240"/>
            <a:ext cx="3161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roteolytic fragments of PARP-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685800" y="685800"/>
            <a:ext cx="251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able -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04T23:44:57Z</dcterms:created>
  <dc:creator>Physiology</dc:creator>
  <dc:description/>
  <dc:language>en-US</dc:language>
  <cp:lastModifiedBy>Prof. P. Prakash Babu</cp:lastModifiedBy>
  <dcterms:modified xsi:type="dcterms:W3CDTF">2010-12-06T09:33:05Z</dcterms:modified>
  <cp:revision>108</cp:revision>
  <dc:subject/>
  <dc:title>Slide 1</dc:title>
</cp:coreProperties>
</file>